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34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14"/>
          <a:stretch/>
        </p:blipFill>
        <p:spPr>
          <a:xfrm>
            <a:off x="1582636" y="569671"/>
            <a:ext cx="3697030" cy="344525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49275" y="4166483"/>
            <a:ext cx="59310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Supplemental Figure S4. Conservation of the C-terminal end among </a:t>
            </a:r>
            <a:r>
              <a:rPr lang="en-US" altLang="zh-CN" sz="1000" b="1" dirty="0" err="1">
                <a:latin typeface="Arial" panose="020B0604020202020204" pitchFamily="34" charset="0"/>
                <a:cs typeface="宋体" panose="02010600030101010101" pitchFamily="2" charset="-122"/>
              </a:rPr>
              <a:t>herpesviral</a:t>
            </a: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 homologs.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The C-terminal end (F445-L454) is in a medium degree of conservation (scaled color in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PyMol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 with the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ConSurf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 Server)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36080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4</TotalTime>
  <Words>36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1</cp:revision>
  <cp:lastPrinted>2018-01-18T18:33:05Z</cp:lastPrinted>
  <dcterms:created xsi:type="dcterms:W3CDTF">2017-06-08T22:39:00Z</dcterms:created>
  <dcterms:modified xsi:type="dcterms:W3CDTF">2018-07-26T12:42:47Z</dcterms:modified>
</cp:coreProperties>
</file>